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無樣式、無格線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2" autoAdjust="0"/>
    <p:restoredTop sz="99040" autoAdjust="0"/>
  </p:normalViewPr>
  <p:slideViewPr>
    <p:cSldViewPr snapToGrid="0">
      <p:cViewPr varScale="1">
        <p:scale>
          <a:sx n="94" d="100"/>
          <a:sy n="94" d="100"/>
        </p:scale>
        <p:origin x="84" y="3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4429;&#24917;&#20113;\Desktop\ctDNA\&#25991;&#31456;\supplementary\Supplemental%20Tables-&#26356;&#26032;&#38543;&#35775;&#20869;&#23481;%20-%20&#21103;&#264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2188553558047975E-2"/>
          <c:y val="1.8384993438543308E-2"/>
          <c:w val="0.907811446441952"/>
          <c:h val="0.808959478689037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8!$B$1</c:f>
              <c:strCache>
                <c:ptCount val="1"/>
                <c:pt idx="0">
                  <c:v>tissue gene mutatio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8!$A$2:$A$7</c:f>
              <c:strCache>
                <c:ptCount val="6"/>
                <c:pt idx="0">
                  <c:v>TP53</c:v>
                </c:pt>
                <c:pt idx="1">
                  <c:v>EGFR</c:v>
                </c:pt>
                <c:pt idx="2">
                  <c:v>KEAP1</c:v>
                </c:pt>
                <c:pt idx="3">
                  <c:v>NAV3</c:v>
                </c:pt>
                <c:pt idx="4">
                  <c:v>CDKN2A</c:v>
                </c:pt>
                <c:pt idx="5">
                  <c:v>PIK3CA</c:v>
                </c:pt>
              </c:strCache>
            </c:strRef>
          </c:cat>
          <c:val>
            <c:numRef>
              <c:f>Sheet8!$B$2:$B$7</c:f>
              <c:numCache>
                <c:formatCode>0%</c:formatCode>
                <c:ptCount val="6"/>
                <c:pt idx="0">
                  <c:v>0.59740259740259738</c:v>
                </c:pt>
                <c:pt idx="1">
                  <c:v>0.20779220779220786</c:v>
                </c:pt>
                <c:pt idx="2">
                  <c:v>9.0909090909090939E-2</c:v>
                </c:pt>
                <c:pt idx="3">
                  <c:v>7.7922077922077934E-2</c:v>
                </c:pt>
                <c:pt idx="4">
                  <c:v>7.7922077922077934E-2</c:v>
                </c:pt>
                <c:pt idx="5">
                  <c:v>7.792207792207793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2E-41A0-A321-71A4E44434C3}"/>
            </c:ext>
          </c:extLst>
        </c:ser>
        <c:ser>
          <c:idx val="1"/>
          <c:order val="1"/>
          <c:tx>
            <c:strRef>
              <c:f>Sheet8!$D$1</c:f>
              <c:strCache>
                <c:ptCount val="1"/>
                <c:pt idx="0">
                  <c:v>preoperative ctDN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8!$A$2:$A$7</c:f>
              <c:strCache>
                <c:ptCount val="6"/>
                <c:pt idx="0">
                  <c:v>TP53</c:v>
                </c:pt>
                <c:pt idx="1">
                  <c:v>EGFR</c:v>
                </c:pt>
                <c:pt idx="2">
                  <c:v>KEAP1</c:v>
                </c:pt>
                <c:pt idx="3">
                  <c:v>NAV3</c:v>
                </c:pt>
                <c:pt idx="4">
                  <c:v>CDKN2A</c:v>
                </c:pt>
                <c:pt idx="5">
                  <c:v>PIK3CA</c:v>
                </c:pt>
              </c:strCache>
            </c:strRef>
          </c:cat>
          <c:val>
            <c:numRef>
              <c:f>Sheet8!$D$2:$D$7</c:f>
              <c:numCache>
                <c:formatCode>0%</c:formatCode>
                <c:ptCount val="6"/>
                <c:pt idx="0">
                  <c:v>0.37662337662337669</c:v>
                </c:pt>
                <c:pt idx="1">
                  <c:v>0.12987012987012986</c:v>
                </c:pt>
                <c:pt idx="2">
                  <c:v>6.4935064935064929E-2</c:v>
                </c:pt>
                <c:pt idx="3">
                  <c:v>2.5974025974025983E-2</c:v>
                </c:pt>
                <c:pt idx="4">
                  <c:v>3.896103896103896E-2</c:v>
                </c:pt>
                <c:pt idx="5">
                  <c:v>5.194805194805195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62E-41A0-A321-71A4E44434C3}"/>
            </c:ext>
          </c:extLst>
        </c:ser>
        <c:ser>
          <c:idx val="2"/>
          <c:order val="2"/>
          <c:tx>
            <c:strRef>
              <c:f>Sheet8!$F$1</c:f>
              <c:strCache>
                <c:ptCount val="1"/>
                <c:pt idx="0">
                  <c:v>postoperative ctDN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8!$A$2:$A$7</c:f>
              <c:strCache>
                <c:ptCount val="6"/>
                <c:pt idx="0">
                  <c:v>TP53</c:v>
                </c:pt>
                <c:pt idx="1">
                  <c:v>EGFR</c:v>
                </c:pt>
                <c:pt idx="2">
                  <c:v>KEAP1</c:v>
                </c:pt>
                <c:pt idx="3">
                  <c:v>NAV3</c:v>
                </c:pt>
                <c:pt idx="4">
                  <c:v>CDKN2A</c:v>
                </c:pt>
                <c:pt idx="5">
                  <c:v>PIK3CA</c:v>
                </c:pt>
              </c:strCache>
            </c:strRef>
          </c:cat>
          <c:val>
            <c:numRef>
              <c:f>Sheet8!$F$2:$F$7</c:f>
              <c:numCache>
                <c:formatCode>0%</c:formatCode>
                <c:ptCount val="6"/>
                <c:pt idx="0">
                  <c:v>0.25</c:v>
                </c:pt>
                <c:pt idx="1">
                  <c:v>8.3333333333333343E-2</c:v>
                </c:pt>
                <c:pt idx="2">
                  <c:v>2.777777777777779E-2</c:v>
                </c:pt>
                <c:pt idx="3">
                  <c:v>1.3888888888888892E-2</c:v>
                </c:pt>
                <c:pt idx="4">
                  <c:v>0</c:v>
                </c:pt>
                <c:pt idx="5">
                  <c:v>1.388888888888889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62E-41A0-A321-71A4E44434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1892224"/>
        <c:axId val="201893760"/>
      </c:barChart>
      <c:catAx>
        <c:axId val="201892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01893760"/>
        <c:crosses val="autoZero"/>
        <c:auto val="1"/>
        <c:lblAlgn val="ctr"/>
        <c:lblOffset val="100"/>
        <c:noMultiLvlLbl val="0"/>
      </c:catAx>
      <c:valAx>
        <c:axId val="2018937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018922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CAC4C2-8D3A-4A3C-957A-2A06DA5E4CD1}" type="datetimeFigureOut">
              <a:rPr lang="zh-TW" altLang="en-US" smtClean="0"/>
              <a:pPr/>
              <a:t>2019/10/28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6EB609-61C9-428E-815E-CEF11FE4608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6D96DD-3DA1-4945-B3EA-4751D3A353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43A92C2-8587-4512-957D-7D4D0402FA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E828A3-EEC4-4CC7-9835-5044D6B3B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DF4575-A8F8-4CB3-86A8-8FC42EE1D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0EFA13-17CC-4A04-9D77-75C6F1933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8439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D22422-41E2-4394-A7C9-DB59D95CA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1C3D78B-76D4-41D0-91CC-7A64B72762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39BA0C-89FE-4E0F-A4FF-568FB12B4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304794-06F2-46B0-A00B-6A4D3E675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F2F0A9-162C-45AC-B3EA-B36004AAA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7106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CB0B93A-AB57-4E24-9590-3798D2860A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C2262C-079E-46F2-B949-5EFDBB5624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A697E5-D4DD-4C37-A3AF-0F05FE0A6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0E9B16-29AE-419E-B0B0-66AE220A4C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D2AD01-C425-4EAD-A793-2F7FC49D8D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1604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904675-A0E3-409E-9060-4F4B44C23A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DDC147-B784-429C-AE94-74EE6F47C5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D73D62-72B6-480A-B168-CF2D5CCC8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086C5E-B5F3-41BA-923F-5CA772B47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73A4CA-8870-45EA-8E16-28F0A4DD8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468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7943A3-A782-4207-98FB-3213BD0C44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5072479-35D9-4B6E-9147-ACBE9332C2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B03EAC-AD34-48A1-8835-AF90C354A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9C22A9-62ED-4D44-A3D5-2ABEB39E45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8B3344F-B447-4670-A01A-39BFB5A2D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832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6D10C5-EE81-4954-95ED-B5E9014970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FF1B460-DD82-4AE8-ACEB-14ED61E2EF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FF7ABCF-086B-46A1-9BC9-E1FA6C28E8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EF7EBAB-7EE4-4EBE-91E6-21358F1ED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91F936E-5CC1-42AB-97A7-BAC475D1E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E490429-242F-465E-ADBD-241A6E387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083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15A12A-1242-4F92-B0EE-3F786DFE79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57520E-915D-4551-888B-8FB37E8AFA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54A3606-3C3F-404F-841C-B0FC2C1526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D781891-EA40-4642-BE0B-8E9C2BB451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30764ED-C88E-43A7-8082-AD88F9B7C0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3B1EF9B-4307-47DE-BA4A-7C7B01E53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882789E-258C-441A-8368-7F124C30C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96FAE80-3E55-4ABF-8A82-1DCDF4D28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951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A6C16E-41EF-49B7-B8F8-F5690EF578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08B4E85-DA38-4244-BE24-37639A802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A9C0361-15FC-45C2-818F-0BDE0554A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8168336-90D8-4C67-A78A-03F895C48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4209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E7EF27B-67F4-4F86-8C4F-038344CDE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303BA1C-B891-423B-88D8-16F17B201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E5E5F32-BF47-4230-B185-BD544937C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549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9BBFB2-1680-4A33-BEC0-126B12CAC9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18360C2-8CA3-407F-B8C3-14047A15B0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63CFBBF-6568-4FD4-B39E-8054D3C10C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826B5E9-784B-4A09-A433-180685E0B1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C260FF7-A445-4979-B1E8-11A07722D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EC809D-DE72-4091-A96B-A4CE888D4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6475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A7D272-B517-4748-BC7C-4F627BD56B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E584E81-1557-4F4A-BC15-2AFB3B763C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BED0B81-4492-463F-9BD2-F3DFB9804D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9AB748-FDBF-42A3-9FE7-3BEBD6395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13BE649-FC33-45E1-911B-BE4AC6EBF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6B75D5-4E44-4096-BBE7-9C2DFADF6C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524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20DD375-DB52-4474-BF77-0F9BA7ADC2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4FA5FEB-BD10-49BB-9558-B07E75D957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1D11A6-650B-4838-B1F0-0970B69A44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EF279-143F-432C-86C7-5DF32BFABA38}" type="datetimeFigureOut">
              <a:rPr lang="zh-CN" altLang="en-US" smtClean="0"/>
              <a:pPr/>
              <a:t>2019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A19157-A037-4DB6-B056-C9C306A94E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D23483-F7E6-4B9D-B019-6DAF0E7A64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4B5AAD-CF42-4F3A-B024-4AA382EDE6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0790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CECE1170-CF8B-48D2-8A41-9A7E271C248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62615940"/>
              </p:ext>
            </p:extLst>
          </p:nvPr>
        </p:nvGraphicFramePr>
        <p:xfrm>
          <a:off x="2920084" y="1051241"/>
          <a:ext cx="6205928" cy="4054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BEFE1E25-F3FF-48A2-8299-D3C25035BDA2}"/>
              </a:ext>
            </a:extLst>
          </p:cNvPr>
          <p:cNvSpPr txBox="1"/>
          <p:nvPr/>
        </p:nvSpPr>
        <p:spPr>
          <a:xfrm>
            <a:off x="1095448" y="5622093"/>
            <a:ext cx="98551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S1: The most frequently detected mutations in tumor tissue and ctDN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3139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30</TotalTime>
  <Words>14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慕云 彭</dc:creator>
  <cp:lastModifiedBy>慕云 彭</cp:lastModifiedBy>
  <cp:revision>55</cp:revision>
  <dcterms:created xsi:type="dcterms:W3CDTF">2019-04-28T08:44:38Z</dcterms:created>
  <dcterms:modified xsi:type="dcterms:W3CDTF">2019-10-28T15:52:23Z</dcterms:modified>
</cp:coreProperties>
</file>